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57" r:id="rId2"/>
    <p:sldId id="258" r:id="rId3"/>
    <p:sldId id="256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60" y="2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22407C-204A-44A5-A72C-FF73DB715963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35D1CB-5552-4EDA-8D81-12D18610D1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669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0.04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35D1CB-5552-4EDA-8D81-12D18610D19F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1053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4414EF-D33F-0BC6-398A-4EA7CC755B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B4D7B30-8957-D659-8C22-16F3AA2383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27D580-7F10-DC41-BE6A-24BE3210C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273D6A-464B-5E46-72DF-829C7D3AC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9F250C-47E2-31BE-57CB-918229E91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336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57FC45-2974-18D2-BA5B-822D609F3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7435F6-4898-8D32-92E0-637CA08E9D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201035-10E5-35CB-A2E0-B46573197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B812C4-8656-6EB4-83AD-213095449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297206-6E91-9F56-8F35-102D9EFD1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708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1311211-7AFF-81B7-FE91-BEAD2FBB83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FB7F7E-E2CE-A35F-2588-AB3E52B15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513405-6FAB-4916-50C9-1DBAFAC69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389193-F77B-28DF-FF61-C47EC9B62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0699FA-3DF1-FD73-A5B5-C6DFE4A20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0174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E1C5D4-10F6-2BCC-02AF-E936F648A6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527CA6-61D5-BFF6-C4CD-2E09A84A00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26C9DD-D6B0-CB67-9EF7-0736BF251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D2C982-DAF9-9A6F-FDA3-75E5D359D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0A2D9B-8312-3418-C944-3929F8983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67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2B1991-9362-3B2E-C714-844B5E09E8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3E3A93A-7E4F-72C4-8D22-5FA9849AB8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A2E3B6-B7DF-3DE0-56C7-C0A8DFD6F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8C38AC-15F7-427A-60FC-C566E3DA5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2DDFDF-3A4D-6927-5F9A-15E24A54E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3145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1F4602-6DDF-75B9-5192-A9C572A737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D282B2-9249-8E04-A1F4-9235A8AA93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BF8B976-61CB-5719-DEDE-DC85470CE5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9DA573-4250-2A04-F482-7711BCCE2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BFD9983-CC41-DDA4-7DF9-8C02BD4F3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7BC95AF-7858-ADD7-A0F6-3FD08926D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1420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684540-E93E-54DA-5C19-760F17C8D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6AB3F1-8E55-5A38-068D-7BACCE2B81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F4D68D4-59FF-0B22-3384-1978932E90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FD50C41-0F30-02B2-8A39-3A38590E9D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1B65F75-9D32-C724-5A64-D3B81E893B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461AC57-9D93-4F0B-8127-BEB896138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6026E1B-321C-BBF8-9EE5-78A719783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AE3E6D5-BBD3-66E7-FE65-F5FAC5F31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0819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FA0BAD-D034-EA10-A4DB-B86E5460A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FBAEA63-AA53-7612-6BF4-B2531B1A9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889FC4D-67D9-07C1-09ED-2FF873C8A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73DCC34-9527-4589-CC2C-C2329BF07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0847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34B08C3-0C7E-64C2-0D66-59C4CD628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41214D7-8115-8BA8-5D33-CF1E64F0E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CEB8A1A-CFAC-F141-1004-C25F25F86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019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04364F-E9A5-E804-5226-79CE7BA33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8E7322-04C6-A90C-E17A-F8313F3065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8F6747D-0579-0B05-6D99-940B97495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0C8726-37FD-A8D8-BB47-54BD6649E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05F48B-1D74-866E-E6F8-4FB554385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537158-F202-DC90-DDCB-2E8C7F911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5531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798862-1EA8-16AF-9482-0EAD6ECB7F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CFC082A-2C50-815E-B52F-CC8C689640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A894219-4AFE-DA5B-AC90-B410EA99E6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007AD7-2DBC-36B0-2536-85E299BA7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A4CC89-5E9B-62F6-B985-B6BF1937F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ADF69BF-FC9A-AC29-C461-09D91EBA4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471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EBD86A6-B4DC-64F6-58A4-81C36FD586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2D79F4-803C-560B-E484-DD5C084E6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97C2C9-4E6F-BFC5-2A34-662DB7FF1B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1A449C-8EC7-6B8C-8125-5970529DBA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0D16E7-54A7-378A-841E-1E5D98F994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9603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96E059C-5A23-BC56-759A-35B3A0B835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2851" y="0"/>
            <a:ext cx="914629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20240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954295F-9709-4C74-191D-9627EFA6BF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1111" y="0"/>
            <a:ext cx="910977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38312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3A2256D-0E1C-A874-197B-30D7D49E64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3599" y="0"/>
            <a:ext cx="908480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05106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EB7F65D-EB3C-E740-8716-548D46D994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06336" y="6525729"/>
            <a:ext cx="333375" cy="20002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2D835FB-E05E-7242-296D-FCC68D61A006}"/>
              </a:ext>
            </a:extLst>
          </p:cNvPr>
          <p:cNvSpPr txBox="1"/>
          <p:nvPr/>
        </p:nvSpPr>
        <p:spPr>
          <a:xfrm>
            <a:off x="10425695" y="6448755"/>
            <a:ext cx="7187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50" b="0" i="0" u="none" strike="noStrike" kern="1200" cap="none" spc="0" normalizeH="0" baseline="0" noProof="0" dirty="0">
                <a:ln>
                  <a:noFill/>
                </a:ln>
                <a:solidFill>
                  <a:schemeClr val="bg2">
                    <a:lumMod val="50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0.04</a:t>
            </a:r>
            <a:endParaRPr kumimoji="0" lang="zh-CN" altLang="en-US" sz="1150" b="0" i="0" u="none" strike="noStrike" kern="1200" cap="none" spc="0" normalizeH="0" baseline="0" noProof="0" dirty="0">
              <a:ln>
                <a:noFill/>
              </a:ln>
              <a:solidFill>
                <a:schemeClr val="bg2">
                  <a:lumMod val="50000"/>
                </a:schemeClr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3EE98B58-DB3F-5173-0CC7-76763B1017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9327" y="0"/>
            <a:ext cx="907334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22535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80CCB7-419D-7B8A-EA84-CDB4A0294EC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8D1294B-6996-F831-2BCB-5205A66B38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1767" y="0"/>
            <a:ext cx="904846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89789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DE277C-E734-445A-9B56-C442AF4A3D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50AEDE1-7548-58B9-7037-E480933F06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7132" y="0"/>
            <a:ext cx="905773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093670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497EE1-E9BC-E87C-1521-D09F4946FC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582109A-FE41-FBEC-47C0-544C4A225A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8859" y="0"/>
            <a:ext cx="911428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622610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78D62A-55C8-DB52-A933-1F2B3611BF4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5212B34-7011-4202-1567-D2E4C70153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1531" y="0"/>
            <a:ext cx="90689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6290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6DA1EF5-0968-CD56-DF5F-B2ED36B888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8FC764B-1009-4305-E9CF-DBE3D2B5AE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2746" y="0"/>
            <a:ext cx="906650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111875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445ED80-1CDD-CA94-029A-CA274FF9D3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D7FB8F2-C56C-34AD-9702-A7A0C17B95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6837" y="0"/>
            <a:ext cx="909832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724290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C72CFD-E215-D42D-0A12-603034B8D7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57C2E0F-2A64-D5A7-692A-4201253EF3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7015" y="0"/>
            <a:ext cx="907797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570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C8F4C96-B5C5-054E-EEFD-92A6B03465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0270" y="0"/>
            <a:ext cx="917145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341978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7DAAFBE-0A6D-09E9-6C1A-E417FA2338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74FE563-7000-F4DE-F4E3-DA7D180FAF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8921" y="0"/>
            <a:ext cx="909415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63530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97E3F3B-36BF-CDC8-D687-957B33F50C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5430" y="0"/>
            <a:ext cx="912114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25973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CF2629F-5F45-5C3F-6DDA-1A9E872271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3411" y="0"/>
            <a:ext cx="910517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4529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3528637-3C40-D796-806E-FC3996BF49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7688" y="0"/>
            <a:ext cx="911662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2412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54FFBE0-CDBE-FB5C-739B-2F45B2F325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1767" y="0"/>
            <a:ext cx="904846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51939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BAC94B47-5722-D4C4-691C-90337CC109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7955" y="0"/>
            <a:ext cx="909609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12551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ABAF583-54F6-BDBA-C600-3652340854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4821" y="0"/>
            <a:ext cx="906235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93959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E6A408B-8220-CE41-EC0D-6A0BC63CEE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2233" y="0"/>
            <a:ext cx="910753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692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3</Words>
  <Application>Microsoft Office PowerPoint</Application>
  <PresentationFormat>宽屏</PresentationFormat>
  <Paragraphs>3</Paragraphs>
  <Slides>2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xiaoli</dc:creator>
  <cp:lastModifiedBy>lixiaoli</cp:lastModifiedBy>
  <cp:revision>6</cp:revision>
  <dcterms:created xsi:type="dcterms:W3CDTF">2025-11-24T08:54:16Z</dcterms:created>
  <dcterms:modified xsi:type="dcterms:W3CDTF">2025-11-24T12:41:38Z</dcterms:modified>
</cp:coreProperties>
</file>